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BD3E1-6326-EAEA-AA4E-CB5664E98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D0526-7E61-4955-C031-9EA89C7562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F2C1E-38EC-8B8A-A7BE-EC040CC8A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AADFBC-C91F-5CBC-54B3-4C658984D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2583A-2352-4C78-86BB-774E98FF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3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E30B9-C040-132F-A1C4-8172C2800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3955B-6253-0D82-33E2-EDD1B7AB2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9A5B06-6F2A-5AE5-BE9C-DD07ECCCD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EE445-1621-FBC9-E792-43D760986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369B8-D6CE-27EA-7498-70B34AE5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165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880743-1CFB-AC71-338B-581B6772AD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10A6E-5332-4B08-0A1D-0DC9340D0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D51BD-84B4-7976-24EC-094010A8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31B07-82A2-E942-D06E-FFC5B0D4C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F6A76-8A1F-0688-EE6F-2078EAFE5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5551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3E397-79D5-30F9-A8C0-F3B86E15F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9610C1-7A98-BF48-A2AF-683559E1A8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0C6C2-AA6B-EB49-2583-64B6A950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CBB0F-A3C7-9429-880E-1FC64B19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91E40-FF26-D932-0EF5-9DDB64776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4221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3D8DF-71DA-8218-28D6-E7EC6AE7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B982E-D9EE-5835-E4D2-350C5DAE5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7E71C-5258-791B-3B64-E2B907D76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F21D1-DCBC-169D-670B-397A75146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D0D0E-E25F-538C-3CED-F7DB0DF3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4048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48F06-69FF-335F-695D-069C1F7E3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8A1050-E907-ECD8-155C-B94F5451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3AD79C-6A2F-E8B2-F807-B0ADDE505B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77B32F-B922-FC4C-493F-BEAC65115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B2302-3A20-03B8-4459-5A6B28CCC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91015-9DED-EFBE-5779-FCAC1CB78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648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F1416-A4CA-1D91-A003-DD2AAF435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432463-0B34-A737-65BB-F6FCAC0A3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113B73-E643-3092-50C9-836C9273E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147ECC-A451-466E-6ECB-1BE0B4500B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076EE5-C818-67D0-7AAB-5F69949C86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4E11F5-A3FB-42D9-A9D0-EFE909521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E7305-6858-DBEE-881F-76F2350B1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975E74-89A1-F5D2-9C87-2D7AC19DD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21310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F422E-8E1D-99B9-8B97-615EF683F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40BCA1-6E04-5962-505B-0E17E5405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16ACF3-E789-0CEA-3936-FD252725E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920E13-E437-C9B0-D852-7871D0942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3609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46A43E-DC2B-F021-58DF-61A3C4743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7B6230-23B2-2C7D-EF85-43A070D26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6D0EF5-46BD-D13C-40C4-DAFB822B6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0893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EBB53-9C26-4294-175C-1D460F48F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3EC4A-5007-1117-DB6C-A6FDF0C19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1B1829-202B-854C-33F2-199B1F880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DE4F7-D23B-5599-8F0A-7F2F10EF1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A92CD-7C91-D174-09C5-DCC96EDDC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75C27-6ECB-2D3D-5FF3-899FB7237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2407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417BF-3F53-8031-0BAB-23C8DE041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C1DF2B-D017-650A-D31A-5C0EA89939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728D31-D4E1-C75A-3FC7-5C3FD85F9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2918E-FA99-6637-6D5E-D507AFDC5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834CCB-EB1E-B7C4-EC23-60CCAECD9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C1839-D199-4C5B-37FF-3EA45899E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55112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C2DD5-AC70-7812-5B43-692C6DB30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DEA4D-A887-84F0-E009-C3EDB043B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6AF1-DFBC-6713-64CB-66907C7F6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10548-7A20-B0AA-D96C-22CF5C01C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D20B0-C719-0828-4564-ACEF025D2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28580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3A2036DB-B6D5-41F0-BA9E-84204A53D30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11" t="47609" r="47856" b="-245"/>
          <a:stretch/>
        </p:blipFill>
        <p:spPr bwMode="auto">
          <a:xfrm>
            <a:off x="3932215" y="3065171"/>
            <a:ext cx="3932950" cy="3242276"/>
          </a:xfrm>
          <a:prstGeom prst="rect">
            <a:avLst/>
          </a:prstGeom>
          <a:ln>
            <a:noFill/>
          </a:ln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FF8304BE-095E-4D6C-B03F-F1B7B2351B5F}"/>
              </a:ext>
            </a:extLst>
          </p:cNvPr>
          <p:cNvSpPr/>
          <p:nvPr/>
        </p:nvSpPr>
        <p:spPr>
          <a:xfrm>
            <a:off x="4448535" y="4060256"/>
            <a:ext cx="2808000" cy="25514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AE61B4A-24C7-48CF-B7EC-484CBDD1E12D}"/>
              </a:ext>
            </a:extLst>
          </p:cNvPr>
          <p:cNvSpPr txBox="1"/>
          <p:nvPr/>
        </p:nvSpPr>
        <p:spPr>
          <a:xfrm>
            <a:off x="7839283" y="4030485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F18CD91-F412-0605-CBC3-5230A811F871}"/>
              </a:ext>
            </a:extLst>
          </p:cNvPr>
          <p:cNvSpPr txBox="1"/>
          <p:nvPr/>
        </p:nvSpPr>
        <p:spPr>
          <a:xfrm rot="16200000">
            <a:off x="4487070" y="2584977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FA560AC-65E0-C811-AC6D-A51932426749}"/>
              </a:ext>
            </a:extLst>
          </p:cNvPr>
          <p:cNvSpPr txBox="1"/>
          <p:nvPr/>
        </p:nvSpPr>
        <p:spPr>
          <a:xfrm rot="16200000">
            <a:off x="5124727" y="1375239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885D2D-F2C9-698B-6BF2-991AC6B4B0CF}"/>
              </a:ext>
            </a:extLst>
          </p:cNvPr>
          <p:cNvSpPr txBox="1"/>
          <p:nvPr/>
        </p:nvSpPr>
        <p:spPr>
          <a:xfrm rot="16200000">
            <a:off x="4665187" y="2296356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BBDDE54-C8BA-CAFC-3ECC-1EBB1C802EBB}"/>
              </a:ext>
            </a:extLst>
          </p:cNvPr>
          <p:cNvSpPr txBox="1"/>
          <p:nvPr/>
        </p:nvSpPr>
        <p:spPr>
          <a:xfrm rot="16200000">
            <a:off x="5424476" y="2175982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D1D833C-FAF1-4F22-0492-D0186A4E43DA}"/>
              </a:ext>
            </a:extLst>
          </p:cNvPr>
          <p:cNvSpPr txBox="1"/>
          <p:nvPr/>
        </p:nvSpPr>
        <p:spPr>
          <a:xfrm rot="16200000">
            <a:off x="5142865" y="2349106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27246B7-474A-DFD9-69EC-439DAEB400CE}"/>
              </a:ext>
            </a:extLst>
          </p:cNvPr>
          <p:cNvSpPr txBox="1"/>
          <p:nvPr/>
        </p:nvSpPr>
        <p:spPr>
          <a:xfrm rot="16200000">
            <a:off x="5585573" y="1421496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3FBEC4D9-3295-6C26-855C-3FB3B3A66D69}"/>
              </a:ext>
            </a:extLst>
          </p:cNvPr>
          <p:cNvCxnSpPr>
            <a:cxnSpLocks/>
          </p:cNvCxnSpPr>
          <p:nvPr/>
        </p:nvCxnSpPr>
        <p:spPr>
          <a:xfrm>
            <a:off x="4507763" y="2928990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9C981CE-4A0F-DE34-FC5A-B32F4AC89FA6}"/>
              </a:ext>
            </a:extLst>
          </p:cNvPr>
          <p:cNvCxnSpPr>
            <a:cxnSpLocks/>
          </p:cNvCxnSpPr>
          <p:nvPr/>
        </p:nvCxnSpPr>
        <p:spPr>
          <a:xfrm>
            <a:off x="4971589" y="2928990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C23C6815-DE71-81DE-A4CE-BFE98A0F9FA5}"/>
              </a:ext>
            </a:extLst>
          </p:cNvPr>
          <p:cNvCxnSpPr>
            <a:cxnSpLocks/>
          </p:cNvCxnSpPr>
          <p:nvPr/>
        </p:nvCxnSpPr>
        <p:spPr>
          <a:xfrm>
            <a:off x="5432434" y="2928741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58370A8D-9F38-9A99-C15F-DD3E71C973A6}"/>
              </a:ext>
            </a:extLst>
          </p:cNvPr>
          <p:cNvCxnSpPr>
            <a:cxnSpLocks/>
          </p:cNvCxnSpPr>
          <p:nvPr/>
        </p:nvCxnSpPr>
        <p:spPr>
          <a:xfrm>
            <a:off x="5886914" y="2928741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C8A6A26E-9260-D13A-EF68-5F98A7FDDA48}"/>
              </a:ext>
            </a:extLst>
          </p:cNvPr>
          <p:cNvCxnSpPr>
            <a:cxnSpLocks/>
          </p:cNvCxnSpPr>
          <p:nvPr/>
        </p:nvCxnSpPr>
        <p:spPr>
          <a:xfrm>
            <a:off x="6336563" y="2931156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24734D5-DFD2-47C1-8AE7-6E3205DC59E6}"/>
              </a:ext>
            </a:extLst>
          </p:cNvPr>
          <p:cNvCxnSpPr>
            <a:cxnSpLocks/>
          </p:cNvCxnSpPr>
          <p:nvPr/>
        </p:nvCxnSpPr>
        <p:spPr>
          <a:xfrm>
            <a:off x="6793763" y="2928741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EC2E8EA6-A20A-35D2-D0A5-B0028E3ACA6D}"/>
              </a:ext>
            </a:extLst>
          </p:cNvPr>
          <p:cNvSpPr txBox="1"/>
          <p:nvPr/>
        </p:nvSpPr>
        <p:spPr>
          <a:xfrm>
            <a:off x="3917523" y="2964659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3478172-035B-93AE-43FC-BEAF95200D04}"/>
              </a:ext>
            </a:extLst>
          </p:cNvPr>
          <p:cNvSpPr txBox="1"/>
          <p:nvPr/>
        </p:nvSpPr>
        <p:spPr>
          <a:xfrm>
            <a:off x="3536718" y="3244126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3516EE4-8592-09E2-A1FB-C3EBA0F4F480}"/>
              </a:ext>
            </a:extLst>
          </p:cNvPr>
          <p:cNvSpPr txBox="1"/>
          <p:nvPr/>
        </p:nvSpPr>
        <p:spPr>
          <a:xfrm>
            <a:off x="4443158" y="2947933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58BABFA-F3B5-17B3-CB39-078488A77CB4}"/>
              </a:ext>
            </a:extLst>
          </p:cNvPr>
          <p:cNvSpPr txBox="1"/>
          <p:nvPr/>
        </p:nvSpPr>
        <p:spPr>
          <a:xfrm>
            <a:off x="4443158" y="3197319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4B8D9AE-C68A-1E9A-0E96-BD95CD5718C5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1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A00FD91D-A675-425F-ABDC-104426F7837D}"/>
              </a:ext>
            </a:extLst>
          </p:cNvPr>
          <p:cNvCxnSpPr>
            <a:cxnSpLocks/>
          </p:cNvCxnSpPr>
          <p:nvPr/>
        </p:nvCxnSpPr>
        <p:spPr>
          <a:xfrm>
            <a:off x="4103746" y="453438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36">
            <a:extLst>
              <a:ext uri="{FF2B5EF4-FFF2-40B4-BE49-F238E27FC236}">
                <a16:creationId xmlns:a16="http://schemas.microsoft.com/office/drawing/2014/main" id="{D3334D52-67E5-400B-B74A-13A899A12F43}"/>
              </a:ext>
            </a:extLst>
          </p:cNvPr>
          <p:cNvSpPr txBox="1"/>
          <p:nvPr/>
        </p:nvSpPr>
        <p:spPr>
          <a:xfrm>
            <a:off x="3775360" y="439231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7C35E000-F0E2-4018-B619-474792331608}"/>
              </a:ext>
            </a:extLst>
          </p:cNvPr>
          <p:cNvCxnSpPr>
            <a:cxnSpLocks/>
          </p:cNvCxnSpPr>
          <p:nvPr/>
        </p:nvCxnSpPr>
        <p:spPr>
          <a:xfrm>
            <a:off x="4105560" y="481318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8">
            <a:extLst>
              <a:ext uri="{FF2B5EF4-FFF2-40B4-BE49-F238E27FC236}">
                <a16:creationId xmlns:a16="http://schemas.microsoft.com/office/drawing/2014/main" id="{1AFAE8A9-C2C6-4250-9F5D-01D1E65A3F2C}"/>
              </a:ext>
            </a:extLst>
          </p:cNvPr>
          <p:cNvSpPr txBox="1"/>
          <p:nvPr/>
        </p:nvSpPr>
        <p:spPr>
          <a:xfrm>
            <a:off x="3777174" y="467111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92D34F1C-B220-4A62-8CC1-BBB1AA721209}"/>
              </a:ext>
            </a:extLst>
          </p:cNvPr>
          <p:cNvCxnSpPr>
            <a:cxnSpLocks/>
          </p:cNvCxnSpPr>
          <p:nvPr/>
        </p:nvCxnSpPr>
        <p:spPr>
          <a:xfrm>
            <a:off x="4105029" y="413832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40">
            <a:extLst>
              <a:ext uri="{FF2B5EF4-FFF2-40B4-BE49-F238E27FC236}">
                <a16:creationId xmlns:a16="http://schemas.microsoft.com/office/drawing/2014/main" id="{1A7407D1-98E7-4719-B711-B1F5739C381E}"/>
              </a:ext>
            </a:extLst>
          </p:cNvPr>
          <p:cNvSpPr txBox="1"/>
          <p:nvPr/>
        </p:nvSpPr>
        <p:spPr>
          <a:xfrm>
            <a:off x="3776643" y="399625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3314C58-59E4-4945-B5C4-598D52272CB3}"/>
              </a:ext>
            </a:extLst>
          </p:cNvPr>
          <p:cNvCxnSpPr>
            <a:cxnSpLocks/>
          </p:cNvCxnSpPr>
          <p:nvPr/>
        </p:nvCxnSpPr>
        <p:spPr>
          <a:xfrm>
            <a:off x="4103555" y="3911851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EC142457-4FB5-4CA4-99CE-08B2563BD7F8}"/>
              </a:ext>
            </a:extLst>
          </p:cNvPr>
          <p:cNvSpPr txBox="1"/>
          <p:nvPr/>
        </p:nvSpPr>
        <p:spPr>
          <a:xfrm>
            <a:off x="3775169" y="37630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C62B9B32-3494-4544-9EE1-5E831871D659}"/>
              </a:ext>
            </a:extLst>
          </p:cNvPr>
          <p:cNvCxnSpPr>
            <a:cxnSpLocks/>
          </p:cNvCxnSpPr>
          <p:nvPr/>
        </p:nvCxnSpPr>
        <p:spPr>
          <a:xfrm>
            <a:off x="4103746" y="542482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8">
            <a:extLst>
              <a:ext uri="{FF2B5EF4-FFF2-40B4-BE49-F238E27FC236}">
                <a16:creationId xmlns:a16="http://schemas.microsoft.com/office/drawing/2014/main" id="{40258BF2-585C-48D6-B657-32F2A410D9F7}"/>
              </a:ext>
            </a:extLst>
          </p:cNvPr>
          <p:cNvSpPr txBox="1"/>
          <p:nvPr/>
        </p:nvSpPr>
        <p:spPr>
          <a:xfrm>
            <a:off x="3775360" y="52827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686E5B6A-BCEC-4006-AC7A-5A33EEE0BAC5}"/>
              </a:ext>
            </a:extLst>
          </p:cNvPr>
          <p:cNvCxnSpPr>
            <a:cxnSpLocks/>
          </p:cNvCxnSpPr>
          <p:nvPr/>
        </p:nvCxnSpPr>
        <p:spPr>
          <a:xfrm>
            <a:off x="4103555" y="378146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42">
            <a:extLst>
              <a:ext uri="{FF2B5EF4-FFF2-40B4-BE49-F238E27FC236}">
                <a16:creationId xmlns:a16="http://schemas.microsoft.com/office/drawing/2014/main" id="{DB16734E-6C6B-4B75-8FA7-8EF4ED0C0A47}"/>
              </a:ext>
            </a:extLst>
          </p:cNvPr>
          <p:cNvSpPr txBox="1"/>
          <p:nvPr/>
        </p:nvSpPr>
        <p:spPr>
          <a:xfrm>
            <a:off x="3690209" y="361230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1855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3</cp:revision>
  <dcterms:created xsi:type="dcterms:W3CDTF">2024-08-13T14:46:47Z</dcterms:created>
  <dcterms:modified xsi:type="dcterms:W3CDTF">2024-08-14T22:17:48Z</dcterms:modified>
</cp:coreProperties>
</file>